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9144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2806" autoAdjust="0"/>
  </p:normalViewPr>
  <p:slideViewPr>
    <p:cSldViewPr>
      <p:cViewPr varScale="1">
        <p:scale>
          <a:sx n="46" d="100"/>
          <a:sy n="46" d="100"/>
        </p:scale>
        <p:origin x="1344" y="62"/>
      </p:cViewPr>
      <p:guideLst>
        <p:guide orient="horz" pos="288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366186"/>
            <a:ext cx="274320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09600" y="366186"/>
            <a:ext cx="802640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963084" y="3875619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09600" y="2133602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6197600" y="2133602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609601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609601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193368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6193368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4766733" y="364068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609601" y="1913468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6400801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2389717" y="7156452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609600" y="2133602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609600" y="8475135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4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4165600" y="8475135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8737600" y="8475135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0" hangingPunct="1">
        <a:spcBef>
          <a:spcPct val="0"/>
        </a:spcBef>
        <a:buNone/>
        <a:defRPr kumimoji="1"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0" hangingPunct="1">
        <a:spcBef>
          <a:spcPct val="20000"/>
        </a:spcBef>
        <a:buFont typeface="Arial" pitchFamily="34" charset="0"/>
        <a:buChar char="•"/>
        <a:defRPr kumimoji="1"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0" hangingPunct="1">
        <a:spcBef>
          <a:spcPct val="20000"/>
        </a:spcBef>
        <a:buFont typeface="Arial" pitchFamily="34" charset="0"/>
        <a:buChar char="–"/>
        <a:defRPr kumimoji="1"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spcBef>
          <a:spcPct val="20000"/>
        </a:spcBef>
        <a:buFont typeface="Arial" pitchFamily="34" charset="0"/>
        <a:buChar char="–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spcBef>
          <a:spcPct val="20000"/>
        </a:spcBef>
        <a:buFont typeface="Arial" pitchFamily="34" charset="0"/>
        <a:buChar char="»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spcBef>
          <a:spcPct val="20000"/>
        </a:spcBef>
        <a:buFont typeface="Arial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テキスト ボックス 1"/>
          <p:cNvSpPr txBox="1"/>
          <p:nvPr/>
        </p:nvSpPr>
        <p:spPr>
          <a:xfrm>
            <a:off x="-52643" y="-1828710"/>
            <a:ext cx="207460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  <a:endParaRPr 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174366" y="527825"/>
            <a:ext cx="6256421" cy="4170949"/>
            <a:chOff x="116632" y="2699792"/>
            <a:chExt cx="3519237" cy="2346159"/>
          </a:xfrm>
        </p:grpSpPr>
        <p:pic>
          <p:nvPicPr>
            <p:cNvPr id="2052" name="Picture 4" descr="C:\Users\ImageQuant\Desktop\Sonomi\Fstl1\4. MI\Heart\1-21-2015 Heart2 MI1W\Fibronectin 2-13-2015\Fn_stand 20150213_1422_1_1_5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6632" y="2699792"/>
              <a:ext cx="3519237" cy="23461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7" name="正方形/長方形 22"/>
            <p:cNvSpPr/>
            <p:nvPr/>
          </p:nvSpPr>
          <p:spPr>
            <a:xfrm>
              <a:off x="758157" y="2949568"/>
              <a:ext cx="1440161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sp>
          <p:nvSpPr>
            <p:cNvPr id="38" name="テキスト ボックス 23"/>
            <p:cNvSpPr txBox="1"/>
            <p:nvPr/>
          </p:nvSpPr>
          <p:spPr>
            <a:xfrm>
              <a:off x="667601" y="2739849"/>
              <a:ext cx="907280" cy="236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bronectin </a:t>
              </a:r>
              <a:endParaRPr lang="en-US" sz="213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5806992" y="527825"/>
            <a:ext cx="6256421" cy="4170949"/>
            <a:chOff x="3284984" y="2699792"/>
            <a:chExt cx="3519237" cy="2346159"/>
          </a:xfrm>
        </p:grpSpPr>
        <p:pic>
          <p:nvPicPr>
            <p:cNvPr id="2053" name="Picture 5" descr="C:\Users\ImageQuant\Desktop\Sonomi\Fstl1\4. MI\Heart\1-21-2015 Heart2 MI1W\Collagen I\Collagen I 20150123_1044_6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84984" y="2699792"/>
              <a:ext cx="3519237" cy="23461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" name="正方形/長方形 22"/>
            <p:cNvSpPr/>
            <p:nvPr/>
          </p:nvSpPr>
          <p:spPr>
            <a:xfrm>
              <a:off x="3936034" y="3216593"/>
              <a:ext cx="1309237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sp>
          <p:nvSpPr>
            <p:cNvPr id="42" name="テキスト ボックス 23"/>
            <p:cNvSpPr txBox="1"/>
            <p:nvPr/>
          </p:nvSpPr>
          <p:spPr>
            <a:xfrm>
              <a:off x="3824842" y="2915816"/>
              <a:ext cx="881130" cy="236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llagen I  </a:t>
              </a:r>
              <a:endParaRPr lang="en-US" sz="213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119336" y="4624279"/>
            <a:ext cx="5687655" cy="3791772"/>
            <a:chOff x="85678" y="5004048"/>
            <a:chExt cx="3199306" cy="2132872"/>
          </a:xfrm>
        </p:grpSpPr>
        <p:grpSp>
          <p:nvGrpSpPr>
            <p:cNvPr id="21" name="Group 20"/>
            <p:cNvGrpSpPr/>
            <p:nvPr/>
          </p:nvGrpSpPr>
          <p:grpSpPr>
            <a:xfrm>
              <a:off x="85678" y="5004048"/>
              <a:ext cx="3199306" cy="2132872"/>
              <a:chOff x="85678" y="5004048"/>
              <a:chExt cx="3199306" cy="2132872"/>
            </a:xfrm>
          </p:grpSpPr>
          <p:pic>
            <p:nvPicPr>
              <p:cNvPr id="2054" name="Picture 6" descr="C:\Users\ImageQuant\Desktop\Sonomi\Fstl1\4. MI\Heart\1-21-2015 Heart2 MI1W\aSMA 1-24-2015\aSMA standard 20150124_1258_1_2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5678" y="5004048"/>
                <a:ext cx="3199306" cy="213287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5" name="正方形/長方形 22"/>
              <p:cNvSpPr/>
              <p:nvPr/>
            </p:nvSpPr>
            <p:spPr>
              <a:xfrm>
                <a:off x="639236" y="5827931"/>
                <a:ext cx="1440161" cy="221652"/>
              </a:xfrm>
              <a:prstGeom prst="rect">
                <a:avLst/>
              </a:prstGeom>
              <a:noFill/>
              <a:ln w="12700">
                <a:solidFill>
                  <a:srgbClr val="FF0000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3200"/>
              </a:p>
            </p:txBody>
          </p:sp>
        </p:grpSp>
        <p:sp>
          <p:nvSpPr>
            <p:cNvPr id="46" name="テキスト ボックス 23"/>
            <p:cNvSpPr txBox="1"/>
            <p:nvPr/>
          </p:nvSpPr>
          <p:spPr>
            <a:xfrm>
              <a:off x="548680" y="5561062"/>
              <a:ext cx="557064" cy="236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SMA</a:t>
              </a:r>
              <a:r>
                <a:rPr lang="en-US" sz="2133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213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5857134" y="4361491"/>
            <a:ext cx="6256421" cy="4170949"/>
            <a:chOff x="3313189" y="4856229"/>
            <a:chExt cx="3519237" cy="2346159"/>
          </a:xfrm>
        </p:grpSpPr>
        <p:pic>
          <p:nvPicPr>
            <p:cNvPr id="2055" name="Picture 7" descr="C:\Users\ImageQuant\Desktop\Sonomi\Fstl1\4. MI\Heart\1-21-2015 Heart2 MI1W\sb tubulin\tubulin standard 20150128_1508_1_4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3189" y="4856229"/>
              <a:ext cx="3519237" cy="23461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0" name="正方形/長方形 22"/>
            <p:cNvSpPr/>
            <p:nvPr/>
          </p:nvSpPr>
          <p:spPr>
            <a:xfrm>
              <a:off x="4046142" y="5736873"/>
              <a:ext cx="1309237" cy="221652"/>
            </a:xfrm>
            <a:prstGeom prst="rect">
              <a:avLst/>
            </a:prstGeom>
            <a:noFill/>
            <a:ln w="12700">
              <a:solidFill>
                <a:srgbClr val="FF0000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200"/>
            </a:p>
          </p:txBody>
        </p:sp>
        <p:sp>
          <p:nvSpPr>
            <p:cNvPr id="51" name="テキスト ボックス 23"/>
            <p:cNvSpPr txBox="1"/>
            <p:nvPr/>
          </p:nvSpPr>
          <p:spPr>
            <a:xfrm>
              <a:off x="3938168" y="5455146"/>
              <a:ext cx="645501" cy="2365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133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 </a:t>
              </a:r>
              <a:endParaRPr lang="en-US" sz="2133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37597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4916597"/>
              </p:ext>
            </p:extLst>
          </p:nvPr>
        </p:nvGraphicFramePr>
        <p:xfrm>
          <a:off x="191344" y="323528"/>
          <a:ext cx="11737299" cy="784887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90010"/>
                <a:gridCol w="834551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  <a:gridCol w="612514"/>
              </a:tblGrid>
              <a:tr h="213466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igure 5A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expression of Col1a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WT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97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17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22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08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055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775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366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6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897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681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3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93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70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12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166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300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719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.45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7.36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1.63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2.39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270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7.47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05.9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4.10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2.1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952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34.77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6.06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8.77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9.6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R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95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204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339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56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9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28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840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37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348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23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420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881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69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62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fK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66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56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82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09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70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88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62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00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5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079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468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0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88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72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77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547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0.402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5.74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3.45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262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2.69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6.98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3.4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9.76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3.35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.56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666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415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R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45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63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38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749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70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437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99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9977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304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215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34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79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44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expression of Fn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WT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27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24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45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98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60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303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37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72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323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80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5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62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846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079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04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810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74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.94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5.60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.54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1.49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.281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0.75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2.36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9.4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09.7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.92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65.99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91.847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0.097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09.8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R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20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813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0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09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76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11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.491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.856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5.390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433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785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140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295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14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fK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60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91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18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78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746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991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20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7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59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507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86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28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417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4524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372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988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1.11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2.055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32.7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.062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.915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6.95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70.13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52.47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11.2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8.45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230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069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MI R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431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619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90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3993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137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73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13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686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956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267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10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418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5838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13466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igure 5B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elative intensity of indicated proteins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ibronecti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WT- 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gridSpan="5"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fKO-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4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ollagen 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WT- 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7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33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fKO-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6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1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3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2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SM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WT- 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fKO-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2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68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5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13466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igure 5C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 gridSpan="3">
                  <a:txBody>
                    <a:bodyPr/>
                    <a:lstStyle/>
                    <a:p>
                      <a:pPr algn="l" fontAlgn="b"/>
                      <a:r>
                        <a:rPr lang="el-GR" sz="1100" u="none" strike="noStrike">
                          <a:effectLst/>
                        </a:rPr>
                        <a:t>α</a:t>
                      </a:r>
                      <a:r>
                        <a:rPr lang="en-US" sz="1100" u="none" strike="noStrike">
                          <a:effectLst/>
                        </a:rPr>
                        <a:t>SMA positive density (%)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WT-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414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8.76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962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.677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161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5266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0.96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6.439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9.16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393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4.06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9.219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3.360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.5124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8.7488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3.51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fKO-IA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310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5038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5164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474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921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729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9449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0953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530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932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8563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7.117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350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1343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13466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Figure 5D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403743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-R thick/ Y-G thin ratio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W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1243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355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25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7552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4.5830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456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3.968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8.1232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4063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 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  <a:tr h="205977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cfKO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202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2.17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835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910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1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374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3596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7633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971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624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7694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0.8222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1.525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960" marR="6960" marT="696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5859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</TotalTime>
  <Words>333</Words>
  <Application>Microsoft Office PowerPoint</Application>
  <PresentationFormat>Custom</PresentationFormat>
  <Paragraphs>3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MS PGothic</vt:lpstr>
      <vt:lpstr>Arial</vt:lpstr>
      <vt:lpstr>Calibri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onomi</dc:creator>
  <cp:lastModifiedBy>Whittaker, Linda D</cp:lastModifiedBy>
  <cp:revision>89</cp:revision>
  <dcterms:modified xsi:type="dcterms:W3CDTF">2016-04-22T18:35:49Z</dcterms:modified>
</cp:coreProperties>
</file>